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88" autoAdjust="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9A6D02-3265-4AF0-A2CD-CAC972C82A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4687E72-AD29-430B-B0B8-CA775D157D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659991-DA94-4A40-886F-F979A9EFC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E30455-1B7D-4AB8-9AF6-E2FEF7236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A7D88F-210E-4660-BB53-B0BFD4ED7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9850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C74E85-7C9D-4E60-8AF5-82BC78775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89FE69E-A6B9-4C3D-9795-31353B44C5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E19B92-C2F6-4429-8BF0-7CE9B531B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EB83AD-D0D9-4ACD-93FF-2E69DFA54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C81DB5-751D-4EC7-8AA2-5A28E8733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6055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B2AA519-EA21-4208-AEBB-107328E3A8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1BFA1E0-46E2-4267-90E6-1362E957A2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83FE71-A40F-43BB-963C-3E34D524B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369EF2-735F-4EFD-A21F-9398C12A9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F06C6E-B8EE-4DF8-8299-324779AA0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2684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862D6E-D634-440B-9077-B54EB3C87B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9D0AB8-89CB-481B-8A47-E67A9BD14E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184965-18AE-4793-B05D-1B152B1B6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030CB9-1DBE-4B8C-922E-5D109A0B5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7F6D0F-F016-46DA-9571-39A10C42D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522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D44186-2D01-4165-9033-AC55F60D2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8128FFD-14F1-49D7-B87D-907584422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EF17C6-AD1F-4451-A7BC-82DD8E2DB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E60154-E4C4-40B2-BE07-422FE794C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6A503C-E1D1-463D-9140-F5A0E61AE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4828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9DF177-23B7-4E20-BAED-2D2D3D7812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80A5C7-5843-491B-97E1-3A462D940A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7D5E564-F3D8-4E8E-BC38-D8389DEF8C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62315BF-1E3D-4D69-82D7-B57303126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AAA2D0-3109-4319-8125-F4F37EB76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9B6830-7698-4FB3-A959-26217D574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583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C85888-035F-4105-8B12-0459FBADF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D01478-4157-42E4-A781-7C4F949908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A6595E2-F5DE-40F1-91EF-739481642B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9B40AC4-3A1F-489E-806E-CB901F9904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650D7CE-0B6C-46F5-8DF6-03B5648153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A53234F-8A3A-4250-8E76-A5FC3C819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20B1DF5-0B95-43FC-8282-D9B954103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A1C908A-3D7E-4048-9FC0-ED1916A6B6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840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C0036B-1662-4F1D-8F89-DF4C8C270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1336C24-BD5D-4029-A004-55E3B31D7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AA5E32C-2B41-4F30-A53E-C68B55E94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4FC40D2-CC37-44D3-8068-1DF027F65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7223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C7D5E25-FFED-4FD1-A49E-72A81D889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F65427D-8DB6-4D57-950A-17E964885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5CBB87E-5B3A-450A-B8EE-34F54DA8C0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8864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40EB0D-A866-474E-A409-8028B8E70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15F2DA0-9E3E-49A2-8A49-8B845528AC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86C40E8-0972-470A-AEEB-B3C669FB20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685575-1A03-481C-B5C9-69F982FC3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09245E-2806-49FE-B413-4B5789F8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B7B681-0C26-4C56-89B3-35D7CCBD5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7660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355F8E-BBFD-44CC-B19C-5859B151C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2F9B273-9E25-4DD8-8C8C-D5DEBCF6BC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B214082-7D8F-4D14-83D0-7925434075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400CA1-A166-47B4-8827-165AA3518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89B549-5B40-48B4-B79C-301577BC7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A15C57-07E3-45A8-9C1A-7BA4A2401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6113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03750CD-9584-4F13-870B-EACFA9429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1AFFB6-2392-442E-B991-05A393E5E0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0910B0-F0F7-4662-9AD2-067940CFC6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7B205-14B1-4B18-B909-222623471DF9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015D35-3C92-4276-BBE7-D32AC1E2F0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FE5FED-3538-4EBE-8398-0456F91A52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9CA2-FFED-490E-8822-C1F762F0D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6568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3B39FF0-A931-49A1-B1CF-3FC5A76C4C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13299"/>
            <a:ext cx="6120092" cy="496337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C211D84-FA14-46FD-A5EA-A3B9F0EA61E4}"/>
              </a:ext>
            </a:extLst>
          </p:cNvPr>
          <p:cNvSpPr txBox="1"/>
          <p:nvPr/>
        </p:nvSpPr>
        <p:spPr>
          <a:xfrm>
            <a:off x="451944" y="273269"/>
            <a:ext cx="11193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B PCR and agarose gel electrophoresis analysis of divergent and convergent primers in cDNA and gDNA. 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A711FD8-4E02-42D9-A07C-732EBE7F13F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19973">
            <a:off x="6271060" y="1616088"/>
            <a:ext cx="5763312" cy="43224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4B6D8C8A-9709-41A5-8574-312DDCE6340A}"/>
              </a:ext>
            </a:extLst>
          </p:cNvPr>
          <p:cNvSpPr/>
          <p:nvPr/>
        </p:nvSpPr>
        <p:spPr>
          <a:xfrm>
            <a:off x="9040538" y="3289952"/>
            <a:ext cx="970961" cy="132917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F28838A4-84E7-4CE7-940F-0AE38B192901}"/>
              </a:ext>
            </a:extLst>
          </p:cNvPr>
          <p:cNvCxnSpPr/>
          <p:nvPr/>
        </p:nvCxnSpPr>
        <p:spPr>
          <a:xfrm>
            <a:off x="5940142" y="1719526"/>
            <a:ext cx="3100396" cy="157042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1A212227-67DE-4A9F-AEFD-55BFCAC57484}"/>
              </a:ext>
            </a:extLst>
          </p:cNvPr>
          <p:cNvCxnSpPr>
            <a:cxnSpLocks/>
          </p:cNvCxnSpPr>
          <p:nvPr/>
        </p:nvCxnSpPr>
        <p:spPr>
          <a:xfrm>
            <a:off x="5846386" y="2730465"/>
            <a:ext cx="3100396" cy="188866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7B5906E6-887F-452E-B78E-D252EF2D2617}"/>
              </a:ext>
            </a:extLst>
          </p:cNvPr>
          <p:cNvSpPr txBox="1"/>
          <p:nvPr/>
        </p:nvSpPr>
        <p:spPr>
          <a:xfrm>
            <a:off x="8950364" y="3138622"/>
            <a:ext cx="30471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00" dirty="0">
                <a:solidFill>
                  <a:schemeClr val="bg1"/>
                </a:solidFill>
              </a:rPr>
              <a:t>cDNA</a:t>
            </a:r>
            <a:endParaRPr lang="zh-CN" altLang="en-US" sz="300" dirty="0">
              <a:solidFill>
                <a:schemeClr val="bg1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D31EEE2-06C9-4FB6-95C7-DF44A0C1B86E}"/>
              </a:ext>
            </a:extLst>
          </p:cNvPr>
          <p:cNvSpPr txBox="1"/>
          <p:nvPr/>
        </p:nvSpPr>
        <p:spPr>
          <a:xfrm>
            <a:off x="9105918" y="3132593"/>
            <a:ext cx="33359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00" dirty="0">
                <a:solidFill>
                  <a:schemeClr val="bg1"/>
                </a:solidFill>
              </a:rPr>
              <a:t>gDNA</a:t>
            </a:r>
            <a:endParaRPr lang="zh-CN" altLang="en-US" sz="300" dirty="0">
              <a:solidFill>
                <a:schemeClr val="bg1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CAE1E6B-D7D3-4B2E-B5E0-D44E1793B328}"/>
              </a:ext>
            </a:extLst>
          </p:cNvPr>
          <p:cNvSpPr txBox="1"/>
          <p:nvPr/>
        </p:nvSpPr>
        <p:spPr>
          <a:xfrm>
            <a:off x="9239851" y="3138622"/>
            <a:ext cx="30471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00" dirty="0">
                <a:solidFill>
                  <a:schemeClr val="bg1"/>
                </a:solidFill>
              </a:rPr>
              <a:t>cDNA</a:t>
            </a:r>
            <a:endParaRPr lang="zh-CN" altLang="en-US" sz="300" dirty="0">
              <a:solidFill>
                <a:schemeClr val="bg1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34B5869-B34D-4265-AA8D-BEA9161EDCAB}"/>
              </a:ext>
            </a:extLst>
          </p:cNvPr>
          <p:cNvSpPr txBox="1"/>
          <p:nvPr/>
        </p:nvSpPr>
        <p:spPr>
          <a:xfrm>
            <a:off x="9386526" y="3144182"/>
            <a:ext cx="30471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00" dirty="0">
                <a:solidFill>
                  <a:schemeClr val="bg1"/>
                </a:solidFill>
              </a:rPr>
              <a:t>cDNA</a:t>
            </a:r>
            <a:endParaRPr lang="zh-CN" altLang="en-US" sz="300" dirty="0">
              <a:solidFill>
                <a:schemeClr val="bg1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3D1BD1E-A5E5-460A-86C4-934935DEAAEC}"/>
              </a:ext>
            </a:extLst>
          </p:cNvPr>
          <p:cNvSpPr txBox="1"/>
          <p:nvPr/>
        </p:nvSpPr>
        <p:spPr>
          <a:xfrm>
            <a:off x="9534043" y="3141161"/>
            <a:ext cx="35651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00" dirty="0">
                <a:solidFill>
                  <a:schemeClr val="bg1"/>
                </a:solidFill>
              </a:rPr>
              <a:t>gDNA</a:t>
            </a:r>
            <a:endParaRPr lang="zh-CN" altLang="en-US" sz="300" dirty="0">
              <a:solidFill>
                <a:schemeClr val="bg1"/>
              </a:solidFill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CB86A95-813D-4047-859F-065F07940AF0}"/>
              </a:ext>
            </a:extLst>
          </p:cNvPr>
          <p:cNvSpPr txBox="1"/>
          <p:nvPr/>
        </p:nvSpPr>
        <p:spPr>
          <a:xfrm>
            <a:off x="9688363" y="3141161"/>
            <a:ext cx="33843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00" dirty="0">
                <a:solidFill>
                  <a:schemeClr val="bg1"/>
                </a:solidFill>
              </a:rPr>
              <a:t>gDNA</a:t>
            </a:r>
            <a:endParaRPr lang="zh-CN" altLang="en-US" sz="300" dirty="0">
              <a:solidFill>
                <a:schemeClr val="bg1"/>
              </a:solidFill>
            </a:endParaRPr>
          </a:p>
        </p:txBody>
      </p:sp>
      <p:sp>
        <p:nvSpPr>
          <p:cNvPr id="133" name="流程图: 摘录 132">
            <a:extLst>
              <a:ext uri="{FF2B5EF4-FFF2-40B4-BE49-F238E27FC236}">
                <a16:creationId xmlns:a16="http://schemas.microsoft.com/office/drawing/2014/main" id="{C762342D-AB4F-4944-9154-5CEEE987B34D}"/>
              </a:ext>
            </a:extLst>
          </p:cNvPr>
          <p:cNvSpPr/>
          <p:nvPr/>
        </p:nvSpPr>
        <p:spPr>
          <a:xfrm rot="5400000">
            <a:off x="9424910" y="4676246"/>
            <a:ext cx="47257" cy="47257"/>
          </a:xfrm>
          <a:prstGeom prst="flowChartExtra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流程图: 摘录 133">
            <a:extLst>
              <a:ext uri="{FF2B5EF4-FFF2-40B4-BE49-F238E27FC236}">
                <a16:creationId xmlns:a16="http://schemas.microsoft.com/office/drawing/2014/main" id="{96A87857-168A-4FE0-AAF6-1454D14CE996}"/>
              </a:ext>
            </a:extLst>
          </p:cNvPr>
          <p:cNvSpPr/>
          <p:nvPr/>
        </p:nvSpPr>
        <p:spPr>
          <a:xfrm rot="16200000">
            <a:off x="9356978" y="4676246"/>
            <a:ext cx="47257" cy="47257"/>
          </a:xfrm>
          <a:prstGeom prst="flowChartExtra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流程图: 摘录 134">
            <a:extLst>
              <a:ext uri="{FF2B5EF4-FFF2-40B4-BE49-F238E27FC236}">
                <a16:creationId xmlns:a16="http://schemas.microsoft.com/office/drawing/2014/main" id="{8350BF49-598A-43FE-A247-993C59F070CE}"/>
              </a:ext>
            </a:extLst>
          </p:cNvPr>
          <p:cNvSpPr/>
          <p:nvPr/>
        </p:nvSpPr>
        <p:spPr>
          <a:xfrm rot="5400000">
            <a:off x="9811825" y="4683335"/>
            <a:ext cx="47257" cy="47257"/>
          </a:xfrm>
          <a:prstGeom prst="flowChartExtra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流程图: 摘录 135">
            <a:extLst>
              <a:ext uri="{FF2B5EF4-FFF2-40B4-BE49-F238E27FC236}">
                <a16:creationId xmlns:a16="http://schemas.microsoft.com/office/drawing/2014/main" id="{23E2C581-FBF6-41BB-8EDD-A97FBFE6A57B}"/>
              </a:ext>
            </a:extLst>
          </p:cNvPr>
          <p:cNvSpPr/>
          <p:nvPr/>
        </p:nvSpPr>
        <p:spPr>
          <a:xfrm rot="16200000">
            <a:off x="9743893" y="4683335"/>
            <a:ext cx="47257" cy="47257"/>
          </a:xfrm>
          <a:prstGeom prst="flowChartExtra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流程图: 对照 136">
            <a:extLst>
              <a:ext uri="{FF2B5EF4-FFF2-40B4-BE49-F238E27FC236}">
                <a16:creationId xmlns:a16="http://schemas.microsoft.com/office/drawing/2014/main" id="{600C737D-67FD-489D-9EF6-92ED900B762A}"/>
              </a:ext>
            </a:extLst>
          </p:cNvPr>
          <p:cNvSpPr/>
          <p:nvPr/>
        </p:nvSpPr>
        <p:spPr>
          <a:xfrm rot="16200000">
            <a:off x="9021117" y="4662913"/>
            <a:ext cx="54346" cy="73923"/>
          </a:xfrm>
          <a:prstGeom prst="flowChartCollat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流程图: 对照 137">
            <a:extLst>
              <a:ext uri="{FF2B5EF4-FFF2-40B4-BE49-F238E27FC236}">
                <a16:creationId xmlns:a16="http://schemas.microsoft.com/office/drawing/2014/main" id="{BCA14ED5-CA39-4F62-8EB0-EC97721716CE}"/>
              </a:ext>
            </a:extLst>
          </p:cNvPr>
          <p:cNvSpPr/>
          <p:nvPr/>
        </p:nvSpPr>
        <p:spPr>
          <a:xfrm rot="16200000">
            <a:off x="9213155" y="4666457"/>
            <a:ext cx="54346" cy="73923"/>
          </a:xfrm>
          <a:prstGeom prst="flowChartCollat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流程图: 对照 138">
            <a:extLst>
              <a:ext uri="{FF2B5EF4-FFF2-40B4-BE49-F238E27FC236}">
                <a16:creationId xmlns:a16="http://schemas.microsoft.com/office/drawing/2014/main" id="{15CC8764-3CFD-44C6-85EC-F4F33A1FA137}"/>
              </a:ext>
            </a:extLst>
          </p:cNvPr>
          <p:cNvSpPr/>
          <p:nvPr/>
        </p:nvSpPr>
        <p:spPr>
          <a:xfrm rot="16200000">
            <a:off x="9580857" y="4670002"/>
            <a:ext cx="54346" cy="73923"/>
          </a:xfrm>
          <a:prstGeom prst="flowChartCollat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流程图: 对照 139">
            <a:extLst>
              <a:ext uri="{FF2B5EF4-FFF2-40B4-BE49-F238E27FC236}">
                <a16:creationId xmlns:a16="http://schemas.microsoft.com/office/drawing/2014/main" id="{CC366771-851C-4D18-B261-1308CD5053B7}"/>
              </a:ext>
            </a:extLst>
          </p:cNvPr>
          <p:cNvSpPr/>
          <p:nvPr/>
        </p:nvSpPr>
        <p:spPr>
          <a:xfrm rot="16200000">
            <a:off x="9964934" y="4666457"/>
            <a:ext cx="54346" cy="73923"/>
          </a:xfrm>
          <a:prstGeom prst="flowChartCollat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0DF039F4-0794-4A95-83A7-94B1342341C3}"/>
              </a:ext>
            </a:extLst>
          </p:cNvPr>
          <p:cNvCxnSpPr>
            <a:cxnSpLocks/>
          </p:cNvCxnSpPr>
          <p:nvPr/>
        </p:nvCxnSpPr>
        <p:spPr>
          <a:xfrm>
            <a:off x="9380607" y="4769283"/>
            <a:ext cx="62483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59C44195-E56E-4BF7-902D-C7564B436FDC}"/>
              </a:ext>
            </a:extLst>
          </p:cNvPr>
          <p:cNvCxnSpPr>
            <a:cxnSpLocks/>
          </p:cNvCxnSpPr>
          <p:nvPr/>
        </p:nvCxnSpPr>
        <p:spPr>
          <a:xfrm>
            <a:off x="9048290" y="4769283"/>
            <a:ext cx="229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文本框 142">
            <a:extLst>
              <a:ext uri="{FF2B5EF4-FFF2-40B4-BE49-F238E27FC236}">
                <a16:creationId xmlns:a16="http://schemas.microsoft.com/office/drawing/2014/main" id="{91887242-8F6A-45F2-8304-9FBA06143B27}"/>
              </a:ext>
            </a:extLst>
          </p:cNvPr>
          <p:cNvSpPr txBox="1"/>
          <p:nvPr/>
        </p:nvSpPr>
        <p:spPr>
          <a:xfrm>
            <a:off x="8953084" y="4772827"/>
            <a:ext cx="4423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22A9F0FD-C38C-405C-88AF-12534304505E}"/>
              </a:ext>
            </a:extLst>
          </p:cNvPr>
          <p:cNvSpPr txBox="1"/>
          <p:nvPr/>
        </p:nvSpPr>
        <p:spPr>
          <a:xfrm>
            <a:off x="9525187" y="4781688"/>
            <a:ext cx="49631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rc 20938</a:t>
            </a:r>
            <a:endParaRPr lang="zh-CN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流程图: 对照 144">
            <a:extLst>
              <a:ext uri="{FF2B5EF4-FFF2-40B4-BE49-F238E27FC236}">
                <a16:creationId xmlns:a16="http://schemas.microsoft.com/office/drawing/2014/main" id="{F7FA5BCF-B86C-44E2-A0B1-4EF513F66AB3}"/>
              </a:ext>
            </a:extLst>
          </p:cNvPr>
          <p:cNvSpPr/>
          <p:nvPr/>
        </p:nvSpPr>
        <p:spPr>
          <a:xfrm rot="16200000">
            <a:off x="8915364" y="4914994"/>
            <a:ext cx="54346" cy="73923"/>
          </a:xfrm>
          <a:prstGeom prst="flowChartCollat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B0287ECE-43E5-4029-B5DA-8D5F871FD99A}"/>
              </a:ext>
            </a:extLst>
          </p:cNvPr>
          <p:cNvSpPr txBox="1"/>
          <p:nvPr/>
        </p:nvSpPr>
        <p:spPr>
          <a:xfrm>
            <a:off x="8974153" y="4906325"/>
            <a:ext cx="4963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chemeClr val="bg1"/>
                </a:solidFill>
              </a:rPr>
              <a:t>Convergent primers</a:t>
            </a:r>
            <a:endParaRPr lang="zh-CN" altLang="en-US" sz="500" dirty="0">
              <a:solidFill>
                <a:schemeClr val="bg1"/>
              </a:solidFill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D686D06F-04CB-4384-BDA1-E0DAE2AC38BB}"/>
              </a:ext>
            </a:extLst>
          </p:cNvPr>
          <p:cNvSpPr txBox="1"/>
          <p:nvPr/>
        </p:nvSpPr>
        <p:spPr>
          <a:xfrm>
            <a:off x="9571068" y="4906325"/>
            <a:ext cx="455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chemeClr val="bg1"/>
                </a:solidFill>
              </a:rPr>
              <a:t>Divergent primers</a:t>
            </a:r>
            <a:endParaRPr lang="zh-CN" altLang="en-US" sz="500" dirty="0">
              <a:solidFill>
                <a:schemeClr val="bg1"/>
              </a:solidFill>
            </a:endParaRPr>
          </a:p>
        </p:txBody>
      </p:sp>
      <p:sp>
        <p:nvSpPr>
          <p:cNvPr id="148" name="流程图: 摘录 147">
            <a:extLst>
              <a:ext uri="{FF2B5EF4-FFF2-40B4-BE49-F238E27FC236}">
                <a16:creationId xmlns:a16="http://schemas.microsoft.com/office/drawing/2014/main" id="{E8618FFF-6313-4139-965B-78DAF49940CB}"/>
              </a:ext>
            </a:extLst>
          </p:cNvPr>
          <p:cNvSpPr/>
          <p:nvPr/>
        </p:nvSpPr>
        <p:spPr>
          <a:xfrm rot="5400000">
            <a:off x="9533456" y="4931199"/>
            <a:ext cx="47257" cy="47257"/>
          </a:xfrm>
          <a:prstGeom prst="flowChartExtra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流程图: 摘录 148">
            <a:extLst>
              <a:ext uri="{FF2B5EF4-FFF2-40B4-BE49-F238E27FC236}">
                <a16:creationId xmlns:a16="http://schemas.microsoft.com/office/drawing/2014/main" id="{34B1EB41-51D6-4A83-B74C-B66875374748}"/>
              </a:ext>
            </a:extLst>
          </p:cNvPr>
          <p:cNvSpPr/>
          <p:nvPr/>
        </p:nvSpPr>
        <p:spPr>
          <a:xfrm rot="16200000">
            <a:off x="9465525" y="4931199"/>
            <a:ext cx="47257" cy="47257"/>
          </a:xfrm>
          <a:prstGeom prst="flowChartExtra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7860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32</Words>
  <Application>Microsoft Office PowerPoint</Application>
  <PresentationFormat>宽屏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4</cp:revision>
  <dcterms:created xsi:type="dcterms:W3CDTF">2025-03-04T14:04:08Z</dcterms:created>
  <dcterms:modified xsi:type="dcterms:W3CDTF">2025-03-04T14:50:40Z</dcterms:modified>
</cp:coreProperties>
</file>